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0"/>
    <p:restoredTop sz="94640"/>
  </p:normalViewPr>
  <p:slideViewPr>
    <p:cSldViewPr snapToGrid="0">
      <p:cViewPr>
        <p:scale>
          <a:sx n="66" d="100"/>
          <a:sy n="66" d="100"/>
        </p:scale>
        <p:origin x="1258" y="3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EF5F39-A814-8643-8FB4-547F54627C9F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13AFF0-4EFB-C043-A866-11D6629AC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213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ao et a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13AFF0-4EFB-C043-A866-11D6629AC7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0160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5A5F2A-D2FB-BC6F-C3EF-0A417A3541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AE9EA4-4820-3ECE-DF02-F16D92A56D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0FD80E-94A0-6BC5-307A-C021D6FF2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308705-ECD0-538A-A5FA-180166B7C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EBF9F9-3310-B79D-CEBC-1471BFF07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655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432E6-9EF6-E55F-4277-B0A9AAD10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0C05C4-93F2-4997-7338-C2A6B32936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B294B-FB2C-AF92-D868-D7A053E56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E5D51-6CEE-6C2B-D4BD-45EA8097A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7649EF-5A2C-AFDB-D46C-8CEFE271C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505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054EAF-C5F5-FA07-6DD6-A48F99BAF5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0DA7DE-F73E-CCBD-964D-3B64E46850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4C37F-4683-5438-7E4E-E509871E6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FD7A63-A2F5-00F5-2C80-3E02A1011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16CAD1-4737-5584-81A5-E82B38830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71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85792-0856-9F8A-36D2-425C7D212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55446C-40DF-4239-FEC3-03BFF8B8BE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150EE-9CC8-AA2F-87AE-788B36FBC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3FF02-A51F-6BCA-2F88-1337D976C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699729-93FC-8286-11D0-BE0602FE4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27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F98EC7-3E82-6D6B-B2CE-A883112ED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1D81F6-C4B2-9B65-3C7B-3506E0B919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33ECF-0932-290E-79D8-865AA1BB6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81A9EB-551C-ACA2-DC9C-3220040BB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ED57D3-2654-A761-7FA8-0C13F0FD8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591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FACBBF-9363-3279-3A47-F57282800B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C4BF60-FD57-1D38-944B-2197524965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94066F-3FDF-2FD2-B30F-0085B4B2C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01BE7-6D4C-513B-1BA5-E564D916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E5367-B90A-5769-CF38-2A9315D07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209D80-F78E-6B49-669B-650CBDB59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648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714A4-39F4-1CC8-1D09-30806F2F66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DC77A3-2A2C-2882-E2C2-F4D8AE1CCD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9971B1-63A5-2551-9307-AD65EE98E7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63A6F1-4721-7033-7DC1-7AD890BC2D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193D0B-16A4-E4BC-1F75-90BCFDFA9B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D8CB2E-EC33-B301-356E-099238E0F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E2DFF5-5BED-197A-F6F8-BB2EC182E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FF5ECD-A820-97AD-61A1-FB8A47595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062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61883-0E8F-4346-5979-DE2EAA52C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BAB04C-F39A-F70E-B246-CA15F4FB4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36B826-915D-CFBE-25F7-93313CA4E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969EBC-B5FC-33CD-8B16-16D90E646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636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A1C07F6-1197-648F-4E59-CB8EFF2D5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8EEBF7-121E-2AA9-487B-14773AA4A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4E8BC1-250F-D875-570F-030386BA0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882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304E8-A941-D48D-2D52-19F154139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59E38B-A798-3EF7-A2B8-2B423EA8CF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409BA0-6E92-885A-FC2B-88C20AF1AF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311FBD-059E-7C13-9A79-CC9E656DD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A2BBA0-E6FB-334C-D4A2-7E295E041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E4A28-35EB-E3A1-5FBA-9840924CC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02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34077A-7221-5058-5CE1-008C2F784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6F1770-3CFD-0896-0E80-48834DF99C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75015A-2364-9124-B2C6-01771FA62C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DEC123-D562-B7D0-B279-B8386EE2D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632254-8DBA-B315-5A80-C64747657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07EBE5-816B-6B79-A719-E8BE6E19C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232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F84CB3-5F37-0A33-F45A-D904E5F7F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21FCFC-0FAE-80DD-D03C-E22BBF7DE1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B82B3-A4E1-C67C-BBDC-8D02B838F0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434BE7-FF54-264A-B797-2C327B47A764}" type="datetimeFigureOut">
              <a:rPr lang="en-US" smtClean="0"/>
              <a:t>11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1EE816-E9F0-DFDA-2892-7BA2CE9A00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A5F121-9388-87C7-3EF6-29276023C9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0E6C08-9587-5542-9A5E-C739AC347A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721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E575FFA-D3F6-FD73-94B3-99C5141ED8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2201317"/>
              </p:ext>
            </p:extLst>
          </p:nvPr>
        </p:nvGraphicFramePr>
        <p:xfrm>
          <a:off x="780127" y="643466"/>
          <a:ext cx="10631749" cy="557107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68179">
                  <a:extLst>
                    <a:ext uri="{9D8B030D-6E8A-4147-A177-3AD203B41FA5}">
                      <a16:colId xmlns:a16="http://schemas.microsoft.com/office/drawing/2014/main" val="3733878386"/>
                    </a:ext>
                  </a:extLst>
                </a:gridCol>
                <a:gridCol w="1526587">
                  <a:extLst>
                    <a:ext uri="{9D8B030D-6E8A-4147-A177-3AD203B41FA5}">
                      <a16:colId xmlns:a16="http://schemas.microsoft.com/office/drawing/2014/main" val="1003475891"/>
                    </a:ext>
                  </a:extLst>
                </a:gridCol>
                <a:gridCol w="2204194">
                  <a:extLst>
                    <a:ext uri="{9D8B030D-6E8A-4147-A177-3AD203B41FA5}">
                      <a16:colId xmlns:a16="http://schemas.microsoft.com/office/drawing/2014/main" val="281112524"/>
                    </a:ext>
                  </a:extLst>
                </a:gridCol>
                <a:gridCol w="1459731">
                  <a:extLst>
                    <a:ext uri="{9D8B030D-6E8A-4147-A177-3AD203B41FA5}">
                      <a16:colId xmlns:a16="http://schemas.microsoft.com/office/drawing/2014/main" val="3717094678"/>
                    </a:ext>
                  </a:extLst>
                </a:gridCol>
                <a:gridCol w="1576510">
                  <a:extLst>
                    <a:ext uri="{9D8B030D-6E8A-4147-A177-3AD203B41FA5}">
                      <a16:colId xmlns:a16="http://schemas.microsoft.com/office/drawing/2014/main" val="610985165"/>
                    </a:ext>
                  </a:extLst>
                </a:gridCol>
                <a:gridCol w="1362415">
                  <a:extLst>
                    <a:ext uri="{9D8B030D-6E8A-4147-A177-3AD203B41FA5}">
                      <a16:colId xmlns:a16="http://schemas.microsoft.com/office/drawing/2014/main" val="2017818335"/>
                    </a:ext>
                  </a:extLst>
                </a:gridCol>
                <a:gridCol w="934133">
                  <a:extLst>
                    <a:ext uri="{9D8B030D-6E8A-4147-A177-3AD203B41FA5}">
                      <a16:colId xmlns:a16="http://schemas.microsoft.com/office/drawing/2014/main" val="2444802202"/>
                    </a:ext>
                  </a:extLst>
                </a:gridCol>
              </a:tblGrid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Gen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alse Negativ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alse Positiv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True Positive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cordanc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Sensitivity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PV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276055761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AKT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40337899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BRAF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153794008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TNNB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068145533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sng" strike="noStrike">
                          <a:effectLst/>
                        </a:rPr>
                        <a:t>DDR2</a:t>
                      </a:r>
                      <a:endParaRPr lang="en-US" sz="1700" b="0" i="0" u="sng" strike="noStrike">
                        <a:solidFill>
                          <a:srgbClr val="467886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08480934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GFR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650257271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RBB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82114420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RBB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252487277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BXW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8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280482524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GFR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517985533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KRA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8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112445899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MAP2K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8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8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.0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3294524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NRA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2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796710481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IK3CA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2305218340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TEN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504814356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SMAD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634822773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TP5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8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10554112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4D8E8B6-622D-31A3-F8CD-9048939077EC}"/>
              </a:ext>
            </a:extLst>
          </p:cNvPr>
          <p:cNvSpPr txBox="1"/>
          <p:nvPr/>
        </p:nvSpPr>
        <p:spPr>
          <a:xfrm>
            <a:off x="315685" y="141515"/>
            <a:ext cx="75925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l Table S2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cordance reanalysis of cancer genes.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607924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1E7BA24-C923-6D87-2F72-EB228FE4C1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3771781"/>
              </p:ext>
            </p:extLst>
          </p:nvPr>
        </p:nvGraphicFramePr>
        <p:xfrm>
          <a:off x="780127" y="643466"/>
          <a:ext cx="10631749" cy="557107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68179">
                  <a:extLst>
                    <a:ext uri="{9D8B030D-6E8A-4147-A177-3AD203B41FA5}">
                      <a16:colId xmlns:a16="http://schemas.microsoft.com/office/drawing/2014/main" val="2435614511"/>
                    </a:ext>
                  </a:extLst>
                </a:gridCol>
                <a:gridCol w="1526587">
                  <a:extLst>
                    <a:ext uri="{9D8B030D-6E8A-4147-A177-3AD203B41FA5}">
                      <a16:colId xmlns:a16="http://schemas.microsoft.com/office/drawing/2014/main" val="3004996352"/>
                    </a:ext>
                  </a:extLst>
                </a:gridCol>
                <a:gridCol w="2204194">
                  <a:extLst>
                    <a:ext uri="{9D8B030D-6E8A-4147-A177-3AD203B41FA5}">
                      <a16:colId xmlns:a16="http://schemas.microsoft.com/office/drawing/2014/main" val="309068628"/>
                    </a:ext>
                  </a:extLst>
                </a:gridCol>
                <a:gridCol w="1459731">
                  <a:extLst>
                    <a:ext uri="{9D8B030D-6E8A-4147-A177-3AD203B41FA5}">
                      <a16:colId xmlns:a16="http://schemas.microsoft.com/office/drawing/2014/main" val="994274688"/>
                    </a:ext>
                  </a:extLst>
                </a:gridCol>
                <a:gridCol w="1576510">
                  <a:extLst>
                    <a:ext uri="{9D8B030D-6E8A-4147-A177-3AD203B41FA5}">
                      <a16:colId xmlns:a16="http://schemas.microsoft.com/office/drawing/2014/main" val="2483037133"/>
                    </a:ext>
                  </a:extLst>
                </a:gridCol>
                <a:gridCol w="1362415">
                  <a:extLst>
                    <a:ext uri="{9D8B030D-6E8A-4147-A177-3AD203B41FA5}">
                      <a16:colId xmlns:a16="http://schemas.microsoft.com/office/drawing/2014/main" val="4123868211"/>
                    </a:ext>
                  </a:extLst>
                </a:gridCol>
                <a:gridCol w="934133">
                  <a:extLst>
                    <a:ext uri="{9D8B030D-6E8A-4147-A177-3AD203B41FA5}">
                      <a16:colId xmlns:a16="http://schemas.microsoft.com/office/drawing/2014/main" val="3412419682"/>
                    </a:ext>
                  </a:extLst>
                </a:gridCol>
              </a:tblGrid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Gen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alse Negativ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alse Positiv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True Positive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cordance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Sensitivity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PV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102185126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AKT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772828787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BRAF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2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8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1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760741480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TNNB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8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2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084941579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DR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7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9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5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43772816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GFR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8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1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1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2942431431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RBB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2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2191446307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ERBB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6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7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04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23562316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BXW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3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1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5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291127713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FGFR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7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6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7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763926153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KRA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4035349068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MAP2K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8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1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1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806898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NRAS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2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631128615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IK3CA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8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0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6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720678078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PTEN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3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6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13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0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558421497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SMAD4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9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9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6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2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41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3755987092"/>
                  </a:ext>
                </a:extLst>
              </a:tr>
              <a:tr h="327710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TP53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38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46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37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5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700" u="none" strike="noStrike">
                          <a:effectLst/>
                        </a:rPr>
                        <a:t>0.52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14604" marR="14604" marT="14604" marB="0" anchor="b"/>
                </a:tc>
                <a:extLst>
                  <a:ext uri="{0D108BD9-81ED-4DB2-BD59-A6C34878D82A}">
                    <a16:rowId xmlns:a16="http://schemas.microsoft.com/office/drawing/2014/main" val="154259276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041BA30-CBA0-FB3D-9495-3FBF58FAB07B}"/>
              </a:ext>
            </a:extLst>
          </p:cNvPr>
          <p:cNvSpPr txBox="1"/>
          <p:nvPr/>
        </p:nvSpPr>
        <p:spPr>
          <a:xfrm>
            <a:off x="315685" y="141515"/>
            <a:ext cx="82450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l Table S3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cordance analysis of internal cancer genes.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555405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270</Words>
  <Application>Microsoft Office PowerPoint</Application>
  <PresentationFormat>Widescreen</PresentationFormat>
  <Paragraphs>24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ptos narrow</vt:lpstr>
      <vt:lpstr>Arial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Barrott</dc:creator>
  <cp:lastModifiedBy>MDPI</cp:lastModifiedBy>
  <cp:revision>3</cp:revision>
  <dcterms:created xsi:type="dcterms:W3CDTF">2025-04-01T17:03:56Z</dcterms:created>
  <dcterms:modified xsi:type="dcterms:W3CDTF">2025-11-06T09:03:17Z</dcterms:modified>
</cp:coreProperties>
</file>